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972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7AB5A-0E49-4097-9557-26B5F4AB8434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AABE7-8170-410E-A25B-8361DE26A71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7AB5A-0E49-4097-9557-26B5F4AB8434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AABE7-8170-410E-A25B-8361DE26A71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7AB5A-0E49-4097-9557-26B5F4AB8434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AABE7-8170-410E-A25B-8361DE26A71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7AB5A-0E49-4097-9557-26B5F4AB8434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AABE7-8170-410E-A25B-8361DE26A71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7AB5A-0E49-4097-9557-26B5F4AB8434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AABE7-8170-410E-A25B-8361DE26A71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7AB5A-0E49-4097-9557-26B5F4AB8434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AABE7-8170-410E-A25B-8361DE26A71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7AB5A-0E49-4097-9557-26B5F4AB8434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AABE7-8170-410E-A25B-8361DE26A71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7AB5A-0E49-4097-9557-26B5F4AB8434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AABE7-8170-410E-A25B-8361DE26A71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7AB5A-0E49-4097-9557-26B5F4AB8434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AABE7-8170-410E-A25B-8361DE26A71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7AB5A-0E49-4097-9557-26B5F4AB8434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AABE7-8170-410E-A25B-8361DE26A71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7AB5A-0E49-4097-9557-26B5F4AB8434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AABE7-8170-410E-A25B-8361DE26A71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27AB5A-0E49-4097-9557-26B5F4AB8434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5AABE7-8170-410E-A25B-8361DE26A71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4.bin"/><Relationship Id="rId5" Type="http://schemas.openxmlformats.org/officeDocument/2006/relationships/oleObject" Target="../embeddings/oleObject3.bin"/><Relationship Id="rId4" Type="http://schemas.openxmlformats.org/officeDocument/2006/relationships/oleObject" Target="../embeddings/oleObject2.bin"/><Relationship Id="rId9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"/>
          <p:cNvGrpSpPr/>
          <p:nvPr/>
        </p:nvGrpSpPr>
        <p:grpSpPr>
          <a:xfrm flipH="1">
            <a:off x="5257800" y="914400"/>
            <a:ext cx="3728279" cy="3128389"/>
            <a:chOff x="1377942" y="1371599"/>
            <a:chExt cx="4282979" cy="3776714"/>
          </a:xfrm>
        </p:grpSpPr>
        <p:graphicFrame>
          <p:nvGraphicFramePr>
            <p:cNvPr id="5" name="Object 2"/>
            <p:cNvGraphicFramePr>
              <a:graphicFrameLocks noChangeAspect="1"/>
            </p:cNvGraphicFramePr>
            <p:nvPr/>
          </p:nvGraphicFramePr>
          <p:xfrm>
            <a:off x="1377942" y="1371599"/>
            <a:ext cx="4107905" cy="3352801"/>
          </p:xfrm>
          <a:graphic>
            <a:graphicData uri="http://schemas.openxmlformats.org/presentationml/2006/ole">
              <p:oleObj spid="_x0000_s4098" name="SPW 10.0 Graph" r:id="rId3" imgW="3825720" imgH="3122640" progId="">
                <p:embed/>
              </p:oleObj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1794234" y="4775289"/>
              <a:ext cx="3429001" cy="373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Log</a:t>
              </a:r>
              <a:r>
                <a:rPr lang="en-US" sz="1200" b="1" baseline="-25000" dirty="0" smtClean="0">
                  <a:latin typeface="Times New Roman" pitchFamily="18" charset="0"/>
                  <a:cs typeface="Times New Roman" pitchFamily="18" charset="0"/>
                </a:rPr>
                <a:t>2 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ratio (Microarray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4124451" y="2988792"/>
              <a:ext cx="2743201" cy="329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Log</a:t>
              </a:r>
              <a:r>
                <a:rPr lang="en-US" sz="1200" b="1" baseline="-25000" dirty="0" smtClean="0">
                  <a:latin typeface="Times New Roman" pitchFamily="18" charset="0"/>
                  <a:cs typeface="Times New Roman" pitchFamily="18" charset="0"/>
                </a:rPr>
                <a:t>2 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ratio (real-time PCR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377131" y="1679445"/>
              <a:ext cx="2286000" cy="6217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y=0.888x + 0.5361</a:t>
              </a:r>
            </a:p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R</a:t>
              </a:r>
              <a:r>
                <a:rPr lang="en-US" sz="1200" b="1" baseline="30000" dirty="0" smtClean="0">
                  <a:latin typeface="Times New Roman" pitchFamily="18" charset="0"/>
                  <a:cs typeface="Times New Roman" pitchFamily="18" charset="0"/>
                </a:rPr>
                <a:t>2 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= 0.9496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9" name="Group 3"/>
          <p:cNvGrpSpPr/>
          <p:nvPr/>
        </p:nvGrpSpPr>
        <p:grpSpPr>
          <a:xfrm>
            <a:off x="234956" y="914400"/>
            <a:ext cx="4870443" cy="3184561"/>
            <a:chOff x="-205906" y="-33174"/>
            <a:chExt cx="9308631" cy="4570965"/>
          </a:xfrm>
        </p:grpSpPr>
        <p:graphicFrame>
          <p:nvGraphicFramePr>
            <p:cNvPr id="11" name="Object 12"/>
            <p:cNvGraphicFramePr>
              <a:graphicFrameLocks noChangeAspect="1"/>
            </p:cNvGraphicFramePr>
            <p:nvPr/>
          </p:nvGraphicFramePr>
          <p:xfrm>
            <a:off x="246062" y="2001837"/>
            <a:ext cx="3182937" cy="2341563"/>
          </p:xfrm>
          <a:graphic>
            <a:graphicData uri="http://schemas.openxmlformats.org/presentationml/2006/ole">
              <p:oleObj spid="_x0000_s4099" name="SPW 10.0 Graph" r:id="rId4" imgW="3183026" imgH="2341778" progId="">
                <p:embed/>
              </p:oleObj>
            </a:graphicData>
          </a:graphic>
        </p:graphicFrame>
        <p:graphicFrame>
          <p:nvGraphicFramePr>
            <p:cNvPr id="12" name="Object 16"/>
            <p:cNvGraphicFramePr>
              <a:graphicFrameLocks noChangeAspect="1"/>
            </p:cNvGraphicFramePr>
            <p:nvPr/>
          </p:nvGraphicFramePr>
          <p:xfrm>
            <a:off x="3168649" y="2001837"/>
            <a:ext cx="3097213" cy="2341563"/>
          </p:xfrm>
          <a:graphic>
            <a:graphicData uri="http://schemas.openxmlformats.org/presentationml/2006/ole">
              <p:oleObj spid="_x0000_s4100" name="SPW 10.0 Graph" r:id="rId5" imgW="3097987" imgH="2341778" progId="">
                <p:embed/>
              </p:oleObj>
            </a:graphicData>
          </a:graphic>
        </p:graphicFrame>
        <p:graphicFrame>
          <p:nvGraphicFramePr>
            <p:cNvPr id="13" name="Object 17"/>
            <p:cNvGraphicFramePr>
              <a:graphicFrameLocks noChangeAspect="1"/>
            </p:cNvGraphicFramePr>
            <p:nvPr/>
          </p:nvGraphicFramePr>
          <p:xfrm>
            <a:off x="228600" y="76200"/>
            <a:ext cx="3217862" cy="2341563"/>
          </p:xfrm>
          <a:graphic>
            <a:graphicData uri="http://schemas.openxmlformats.org/presentationml/2006/ole">
              <p:oleObj spid="_x0000_s4101" name="SPW 12.0 Graph" r:id="rId6" imgW="3217774" imgH="2341778" progId="">
                <p:embed/>
              </p:oleObj>
            </a:graphicData>
          </a:graphic>
        </p:graphicFrame>
        <p:graphicFrame>
          <p:nvGraphicFramePr>
            <p:cNvPr id="14" name="Object 18"/>
            <p:cNvGraphicFramePr>
              <a:graphicFrameLocks noChangeAspect="1"/>
            </p:cNvGraphicFramePr>
            <p:nvPr/>
          </p:nvGraphicFramePr>
          <p:xfrm>
            <a:off x="3133725" y="76200"/>
            <a:ext cx="3132137" cy="2341563"/>
          </p:xfrm>
          <a:graphic>
            <a:graphicData uri="http://schemas.openxmlformats.org/presentationml/2006/ole">
              <p:oleObj spid="_x0000_s4102" name="SPW 10.0 Graph" r:id="rId7" imgW="3132734" imgH="2341778" progId="">
                <p:embed/>
              </p:oleObj>
            </a:graphicData>
          </a:graphic>
        </p:graphicFrame>
        <p:graphicFrame>
          <p:nvGraphicFramePr>
            <p:cNvPr id="15" name="Object 20"/>
            <p:cNvGraphicFramePr>
              <a:graphicFrameLocks noChangeAspect="1"/>
            </p:cNvGraphicFramePr>
            <p:nvPr/>
          </p:nvGraphicFramePr>
          <p:xfrm>
            <a:off x="5884862" y="2000450"/>
            <a:ext cx="3217863" cy="2341563"/>
          </p:xfrm>
          <a:graphic>
            <a:graphicData uri="http://schemas.openxmlformats.org/presentationml/2006/ole">
              <p:oleObj spid="_x0000_s4103" name="SPW 10.0 Graph" r:id="rId8" imgW="3217774" imgH="2341778" progId="">
                <p:embed/>
              </p:oleObj>
            </a:graphicData>
          </a:graphic>
        </p:graphicFrame>
        <p:graphicFrame>
          <p:nvGraphicFramePr>
            <p:cNvPr id="16" name="Object 21"/>
            <p:cNvGraphicFramePr>
              <a:graphicFrameLocks noChangeAspect="1"/>
            </p:cNvGraphicFramePr>
            <p:nvPr/>
          </p:nvGraphicFramePr>
          <p:xfrm>
            <a:off x="5902325" y="76200"/>
            <a:ext cx="3182937" cy="2341562"/>
          </p:xfrm>
          <a:graphic>
            <a:graphicData uri="http://schemas.openxmlformats.org/presentationml/2006/ole">
              <p:oleObj spid="_x0000_s4104" name="SPW 10.0 Graph" r:id="rId9" imgW="3183026" imgH="2341778" progId="">
                <p:embed/>
              </p:oleObj>
            </a:graphicData>
          </a:graphic>
        </p:graphicFrame>
        <p:sp>
          <p:nvSpPr>
            <p:cNvPr id="17" name="TextBox 16"/>
            <p:cNvSpPr txBox="1"/>
            <p:nvPr/>
          </p:nvSpPr>
          <p:spPr>
            <a:xfrm rot="16200000">
              <a:off x="-1731900" y="2059393"/>
              <a:ext cx="3581402" cy="5294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Fold      change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8" name="Group 33"/>
            <p:cNvGrpSpPr/>
            <p:nvPr/>
          </p:nvGrpSpPr>
          <p:grpSpPr>
            <a:xfrm>
              <a:off x="655770" y="4140200"/>
              <a:ext cx="2475831" cy="397591"/>
              <a:chOff x="655770" y="4140200"/>
              <a:chExt cx="2475831" cy="397591"/>
            </a:xfrm>
          </p:grpSpPr>
          <p:grpSp>
            <p:nvGrpSpPr>
              <p:cNvPr id="45" name="Group 30"/>
              <p:cNvGrpSpPr/>
              <p:nvPr/>
            </p:nvGrpSpPr>
            <p:grpSpPr>
              <a:xfrm>
                <a:off x="909637" y="4171948"/>
                <a:ext cx="2102169" cy="0"/>
                <a:chOff x="909637" y="3124200"/>
                <a:chExt cx="2102169" cy="0"/>
              </a:xfrm>
            </p:grpSpPr>
            <p:cxnSp>
              <p:nvCxnSpPr>
                <p:cNvPr id="47" name="Straight Connector 46"/>
                <p:cNvCxnSpPr/>
                <p:nvPr/>
              </p:nvCxnSpPr>
              <p:spPr>
                <a:xfrm>
                  <a:off x="1466852" y="3124200"/>
                  <a:ext cx="411480" cy="0"/>
                </a:xfrm>
                <a:prstGeom prst="line">
                  <a:avLst/>
                </a:prstGeom>
                <a:ln w="31750" cmpd="dbl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Straight Connector 47"/>
                <p:cNvCxnSpPr/>
                <p:nvPr/>
              </p:nvCxnSpPr>
              <p:spPr>
                <a:xfrm>
                  <a:off x="909637" y="3124200"/>
                  <a:ext cx="411480" cy="0"/>
                </a:xfrm>
                <a:prstGeom prst="line">
                  <a:avLst/>
                </a:prstGeom>
                <a:ln w="31750" cmpd="dbl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Straight Connector 48"/>
                <p:cNvCxnSpPr/>
                <p:nvPr/>
              </p:nvCxnSpPr>
              <p:spPr>
                <a:xfrm>
                  <a:off x="2031683" y="3124200"/>
                  <a:ext cx="411480" cy="0"/>
                </a:xfrm>
                <a:prstGeom prst="line">
                  <a:avLst/>
                </a:prstGeom>
                <a:ln w="31750" cmpd="dbl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Straight Connector 49"/>
                <p:cNvCxnSpPr/>
                <p:nvPr/>
              </p:nvCxnSpPr>
              <p:spPr>
                <a:xfrm>
                  <a:off x="2600326" y="3124200"/>
                  <a:ext cx="411480" cy="0"/>
                </a:xfrm>
                <a:prstGeom prst="line">
                  <a:avLst/>
                </a:prstGeom>
                <a:ln w="31750" cmpd="dbl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6" name="TextBox 45"/>
              <p:cNvSpPr txBox="1"/>
              <p:nvPr/>
            </p:nvSpPr>
            <p:spPr>
              <a:xfrm>
                <a:off x="655770" y="4140200"/>
                <a:ext cx="2475831" cy="3975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  6     12    24    72  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9" name="Group 38"/>
            <p:cNvGrpSpPr/>
            <p:nvPr/>
          </p:nvGrpSpPr>
          <p:grpSpPr>
            <a:xfrm>
              <a:off x="3722687" y="4171949"/>
              <a:ext cx="2102169" cy="0"/>
              <a:chOff x="909637" y="3124200"/>
              <a:chExt cx="2102169" cy="0"/>
            </a:xfrm>
          </p:grpSpPr>
          <p:cxnSp>
            <p:nvCxnSpPr>
              <p:cNvPr id="41" name="Straight Connector 40"/>
              <p:cNvCxnSpPr/>
              <p:nvPr/>
            </p:nvCxnSpPr>
            <p:spPr>
              <a:xfrm>
                <a:off x="1466852" y="3124200"/>
                <a:ext cx="411480" cy="0"/>
              </a:xfrm>
              <a:prstGeom prst="line">
                <a:avLst/>
              </a:prstGeom>
              <a:ln w="31750" cmpd="dbl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>
                <a:off x="909637" y="3124200"/>
                <a:ext cx="411480" cy="0"/>
              </a:xfrm>
              <a:prstGeom prst="line">
                <a:avLst/>
              </a:prstGeom>
              <a:ln w="31750" cmpd="dbl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/>
              <p:cNvCxnSpPr/>
              <p:nvPr/>
            </p:nvCxnSpPr>
            <p:spPr>
              <a:xfrm>
                <a:off x="2031683" y="3124200"/>
                <a:ext cx="411480" cy="0"/>
              </a:xfrm>
              <a:prstGeom prst="line">
                <a:avLst/>
              </a:prstGeom>
              <a:ln w="31750" cmpd="dbl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>
                <a:off x="2600326" y="3124200"/>
                <a:ext cx="411480" cy="0"/>
              </a:xfrm>
              <a:prstGeom prst="line">
                <a:avLst/>
              </a:prstGeom>
              <a:ln w="31750" cmpd="dbl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 30"/>
            <p:cNvGrpSpPr/>
            <p:nvPr/>
          </p:nvGrpSpPr>
          <p:grpSpPr>
            <a:xfrm>
              <a:off x="6548436" y="4175124"/>
              <a:ext cx="2102169" cy="0"/>
              <a:chOff x="909637" y="3124200"/>
              <a:chExt cx="2102169" cy="0"/>
            </a:xfrm>
          </p:grpSpPr>
          <p:cxnSp>
            <p:nvCxnSpPr>
              <p:cNvPr id="35" name="Straight Connector 34"/>
              <p:cNvCxnSpPr/>
              <p:nvPr/>
            </p:nvCxnSpPr>
            <p:spPr>
              <a:xfrm>
                <a:off x="1466852" y="3124200"/>
                <a:ext cx="411480" cy="0"/>
              </a:xfrm>
              <a:prstGeom prst="line">
                <a:avLst/>
              </a:prstGeom>
              <a:ln w="31750" cmpd="dbl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>
                <a:off x="909637" y="3124200"/>
                <a:ext cx="411480" cy="0"/>
              </a:xfrm>
              <a:prstGeom prst="line">
                <a:avLst/>
              </a:prstGeom>
              <a:ln w="31750" cmpd="dbl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>
                <a:off x="2031683" y="3124200"/>
                <a:ext cx="411480" cy="0"/>
              </a:xfrm>
              <a:prstGeom prst="line">
                <a:avLst/>
              </a:prstGeom>
              <a:ln w="31750" cmpd="dbl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>
                <a:off x="2600326" y="3124200"/>
                <a:ext cx="411480" cy="0"/>
              </a:xfrm>
              <a:prstGeom prst="line">
                <a:avLst/>
              </a:prstGeom>
              <a:ln w="31750" cmpd="dbl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" name="Group 59"/>
            <p:cNvGrpSpPr/>
            <p:nvPr/>
          </p:nvGrpSpPr>
          <p:grpSpPr>
            <a:xfrm>
              <a:off x="801407" y="-33174"/>
              <a:ext cx="3476557" cy="353414"/>
              <a:chOff x="-922618" y="4964192"/>
              <a:chExt cx="3476557" cy="353414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-922618" y="5073566"/>
                <a:ext cx="228601" cy="95250"/>
              </a:xfrm>
              <a:prstGeom prst="rect">
                <a:avLst/>
              </a:prstGeom>
              <a:solidFill>
                <a:srgbClr val="C0C0C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-485706" y="4964192"/>
                <a:ext cx="3039645" cy="3534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latin typeface="Times New Roman" pitchFamily="18" charset="0"/>
                    <a:cs typeface="Times New Roman" pitchFamily="18" charset="0"/>
                  </a:rPr>
                  <a:t>Compatible interaction</a:t>
                </a:r>
              </a:p>
            </p:txBody>
          </p:sp>
        </p:grpSp>
        <p:grpSp>
          <p:nvGrpSpPr>
            <p:cNvPr id="22" name="Group 60"/>
            <p:cNvGrpSpPr/>
            <p:nvPr/>
          </p:nvGrpSpPr>
          <p:grpSpPr>
            <a:xfrm>
              <a:off x="4587974" y="-33174"/>
              <a:ext cx="4323940" cy="353414"/>
              <a:chOff x="758924" y="5126117"/>
              <a:chExt cx="4323940" cy="353414"/>
            </a:xfrm>
          </p:grpSpPr>
          <p:sp>
            <p:nvSpPr>
              <p:cNvPr id="29" name="Rectangle 28"/>
              <p:cNvSpPr/>
              <p:nvPr/>
            </p:nvSpPr>
            <p:spPr>
              <a:xfrm>
                <a:off x="758924" y="5235491"/>
                <a:ext cx="228601" cy="9525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1195836" y="5126117"/>
                <a:ext cx="3887028" cy="3534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latin typeface="Times New Roman" pitchFamily="18" charset="0"/>
                    <a:cs typeface="Times New Roman" pitchFamily="18" charset="0"/>
                  </a:rPr>
                  <a:t>Incompatible interaction</a:t>
                </a:r>
              </a:p>
            </p:txBody>
          </p:sp>
        </p:grpSp>
        <p:sp>
          <p:nvSpPr>
            <p:cNvPr id="23" name="TextBox 22"/>
            <p:cNvSpPr txBox="1"/>
            <p:nvPr/>
          </p:nvSpPr>
          <p:spPr>
            <a:xfrm>
              <a:off x="762000" y="457200"/>
              <a:ext cx="2285999" cy="364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(A) CK213159</a:t>
              </a:r>
              <a:endParaRPr lang="en-US" sz="1000" b="1" u="sng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657599" y="457200"/>
              <a:ext cx="2057400" cy="364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(B) CN009367</a:t>
              </a:r>
              <a:endParaRPr lang="en-US" sz="1000" b="1" u="sng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6476999" y="457200"/>
              <a:ext cx="2285999" cy="364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(C) CD869243</a:t>
              </a:r>
              <a:endParaRPr lang="en-US" sz="1000" b="1" u="sng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762000" y="2355935"/>
              <a:ext cx="2285999" cy="364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(D) BQ295073</a:t>
              </a:r>
              <a:endParaRPr lang="en-US" sz="1000" b="1" u="sng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581400" y="2352675"/>
              <a:ext cx="2285999" cy="3534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(E) CD875175</a:t>
              </a:r>
              <a:endParaRPr lang="en-US" sz="1000" b="1" u="sng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400800" y="2355935"/>
              <a:ext cx="2285999" cy="364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(F) BQ838257</a:t>
              </a:r>
              <a:endParaRPr lang="en-US" sz="1000" b="1" u="sng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51" name="TextBox 50"/>
          <p:cNvSpPr txBox="1"/>
          <p:nvPr/>
        </p:nvSpPr>
        <p:spPr>
          <a:xfrm>
            <a:off x="2133600" y="3810000"/>
            <a:ext cx="1295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 6     12    24    72  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657600" y="3810000"/>
            <a:ext cx="1295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 6     12    24    72  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304800" y="228600"/>
            <a:ext cx="3048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20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5181600" y="228600"/>
            <a:ext cx="3048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20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 flipH="1">
            <a:off x="1295400" y="4114800"/>
            <a:ext cx="29849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Time after Hessian fly infestation (h)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 flipH="1">
            <a:off x="381000" y="5029200"/>
            <a:ext cx="86106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400" b="1" smtClean="0">
                <a:latin typeface="Times New Roman" pitchFamily="18" charset="0"/>
                <a:cs typeface="Times New Roman" pitchFamily="18" charset="0"/>
              </a:rPr>
              <a:t>S3.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Validation of microarray data through </a:t>
            </a:r>
            <a:r>
              <a:rPr lang="en-US" sz="1400" b="1" dirty="0" err="1" smtClean="0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. (A)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results of six representative genes with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GenBank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accession numbers CK213159, CN009367, CD869243, BQ295073, CD875175, and BQ838257. (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) Correlation analysis of microarray and Real-time PCR data sets. </a:t>
            </a:r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121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Office Theme</vt:lpstr>
      <vt:lpstr>SPW 10.0 Graph</vt:lpstr>
      <vt:lpstr>SPW 12.0 Graph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itvan Khajuria</dc:creator>
  <cp:lastModifiedBy>M CHEN</cp:lastModifiedBy>
  <cp:revision>11</cp:revision>
  <dcterms:created xsi:type="dcterms:W3CDTF">2012-08-24T01:54:55Z</dcterms:created>
  <dcterms:modified xsi:type="dcterms:W3CDTF">2013-04-30T19:07:50Z</dcterms:modified>
</cp:coreProperties>
</file>